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24F136-50C8-42E5-B116-EF45A5FE31FE}" v="12" dt="2021-05-05T22:15:04.7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4" autoAdjust="0"/>
    <p:restoredTop sz="95194" autoAdjust="0"/>
  </p:normalViewPr>
  <p:slideViewPr>
    <p:cSldViewPr snapToGrid="0">
      <p:cViewPr>
        <p:scale>
          <a:sx n="80" d="100"/>
          <a:sy n="80" d="100"/>
        </p:scale>
        <p:origin x="2030" y="4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ulo Eduardo Toscano Soares" userId="e475f443e47629d7" providerId="LiveId" clId="{6524F136-50C8-42E5-B116-EF45A5FE31FE}"/>
    <pc:docChg chg="undo custSel addSld modSld">
      <pc:chgData name="Paulo Eduardo Toscano Soares" userId="e475f443e47629d7" providerId="LiveId" clId="{6524F136-50C8-42E5-B116-EF45A5FE31FE}" dt="2021-05-05T23:11:47.042" v="262" actId="14100"/>
      <pc:docMkLst>
        <pc:docMk/>
      </pc:docMkLst>
      <pc:sldChg chg="addSp delSp modSp mod">
        <pc:chgData name="Paulo Eduardo Toscano Soares" userId="e475f443e47629d7" providerId="LiveId" clId="{6524F136-50C8-42E5-B116-EF45A5FE31FE}" dt="2021-05-05T23:11:47.042" v="262" actId="14100"/>
        <pc:sldMkLst>
          <pc:docMk/>
          <pc:sldMk cId="2767018269" sldId="256"/>
        </pc:sldMkLst>
        <pc:spChg chg="del mod ord topLvl">
          <ac:chgData name="Paulo Eduardo Toscano Soares" userId="e475f443e47629d7" providerId="LiveId" clId="{6524F136-50C8-42E5-B116-EF45A5FE31FE}" dt="2021-05-05T21:58:51.291" v="90" actId="478"/>
          <ac:spMkLst>
            <pc:docMk/>
            <pc:sldMk cId="2767018269" sldId="256"/>
            <ac:spMk id="3" creationId="{A5343551-BAAC-49C1-AAFF-7045B1395A8A}"/>
          </ac:spMkLst>
        </pc:spChg>
        <pc:spChg chg="mod ord topLvl">
          <ac:chgData name="Paulo Eduardo Toscano Soares" userId="e475f443e47629d7" providerId="LiveId" clId="{6524F136-50C8-42E5-B116-EF45A5FE31FE}" dt="2021-05-05T22:15:04.700" v="249" actId="164"/>
          <ac:spMkLst>
            <pc:docMk/>
            <pc:sldMk cId="2767018269" sldId="256"/>
            <ac:spMk id="8" creationId="{D1B4BCEA-8625-4721-ABF0-8C20A77DC92F}"/>
          </ac:spMkLst>
        </pc:spChg>
        <pc:spChg chg="mod ord topLvl">
          <ac:chgData name="Paulo Eduardo Toscano Soares" userId="e475f443e47629d7" providerId="LiveId" clId="{6524F136-50C8-42E5-B116-EF45A5FE31FE}" dt="2021-05-05T22:15:04.700" v="249" actId="164"/>
          <ac:spMkLst>
            <pc:docMk/>
            <pc:sldMk cId="2767018269" sldId="256"/>
            <ac:spMk id="9" creationId="{6AF8DBB2-592A-4CCF-A9DA-8F3EF3EEC8B0}"/>
          </ac:spMkLst>
        </pc:spChg>
        <pc:spChg chg="del mod ord topLvl">
          <ac:chgData name="Paulo Eduardo Toscano Soares" userId="e475f443e47629d7" providerId="LiveId" clId="{6524F136-50C8-42E5-B116-EF45A5FE31FE}" dt="2021-05-05T21:58:12.436" v="83" actId="478"/>
          <ac:spMkLst>
            <pc:docMk/>
            <pc:sldMk cId="2767018269" sldId="256"/>
            <ac:spMk id="15" creationId="{BD87B73A-DC83-4EFF-8703-DBEF93C8E5D9}"/>
          </ac:spMkLst>
        </pc:spChg>
        <pc:spChg chg="mod topLvl">
          <ac:chgData name="Paulo Eduardo Toscano Soares" userId="e475f443e47629d7" providerId="LiveId" clId="{6524F136-50C8-42E5-B116-EF45A5FE31FE}" dt="2021-05-05T22:10:37.692" v="199" actId="208"/>
          <ac:spMkLst>
            <pc:docMk/>
            <pc:sldMk cId="2767018269" sldId="256"/>
            <ac:spMk id="16" creationId="{2A2D43BB-9CA4-465C-B4F3-9C28CF6ECF98}"/>
          </ac:spMkLst>
        </pc:spChg>
        <pc:spChg chg="mod ord topLvl">
          <ac:chgData name="Paulo Eduardo Toscano Soares" userId="e475f443e47629d7" providerId="LiveId" clId="{6524F136-50C8-42E5-B116-EF45A5FE31FE}" dt="2021-05-05T22:11:46.855" v="200" actId="165"/>
          <ac:spMkLst>
            <pc:docMk/>
            <pc:sldMk cId="2767018269" sldId="256"/>
            <ac:spMk id="17" creationId="{8A42E6A6-55E3-4D23-8822-A70E7474635B}"/>
          </ac:spMkLst>
        </pc:spChg>
        <pc:spChg chg="del mod ord topLvl">
          <ac:chgData name="Paulo Eduardo Toscano Soares" userId="e475f443e47629d7" providerId="LiveId" clId="{6524F136-50C8-42E5-B116-EF45A5FE31FE}" dt="2021-05-05T21:58:51.291" v="90" actId="478"/>
          <ac:spMkLst>
            <pc:docMk/>
            <pc:sldMk cId="2767018269" sldId="256"/>
            <ac:spMk id="21" creationId="{31A8D9FA-AF59-4F1B-9A8E-70E01CB076C9}"/>
          </ac:spMkLst>
        </pc:spChg>
        <pc:spChg chg="mod ord topLvl">
          <ac:chgData name="Paulo Eduardo Toscano Soares" userId="e475f443e47629d7" providerId="LiveId" clId="{6524F136-50C8-42E5-B116-EF45A5FE31FE}" dt="2021-05-05T22:15:04.700" v="249" actId="164"/>
          <ac:spMkLst>
            <pc:docMk/>
            <pc:sldMk cId="2767018269" sldId="256"/>
            <ac:spMk id="23" creationId="{5A6E3493-A4B8-465D-BD36-A54680F7755F}"/>
          </ac:spMkLst>
        </pc:spChg>
        <pc:spChg chg="add del mod ord topLvl">
          <ac:chgData name="Paulo Eduardo Toscano Soares" userId="e475f443e47629d7" providerId="LiveId" clId="{6524F136-50C8-42E5-B116-EF45A5FE31FE}" dt="2021-05-05T23:11:35.892" v="260" actId="478"/>
          <ac:spMkLst>
            <pc:docMk/>
            <pc:sldMk cId="2767018269" sldId="256"/>
            <ac:spMk id="24" creationId="{BC8C17D4-BC28-4D75-B1B1-E0A896947013}"/>
          </ac:spMkLst>
        </pc:spChg>
        <pc:spChg chg="del mod ord topLvl">
          <ac:chgData name="Paulo Eduardo Toscano Soares" userId="e475f443e47629d7" providerId="LiveId" clId="{6524F136-50C8-42E5-B116-EF45A5FE31FE}" dt="2021-05-05T23:10:47.995" v="257" actId="478"/>
          <ac:spMkLst>
            <pc:docMk/>
            <pc:sldMk cId="2767018269" sldId="256"/>
            <ac:spMk id="25" creationId="{17406819-112C-492B-9A81-3E4589028309}"/>
          </ac:spMkLst>
        </pc:spChg>
        <pc:spChg chg="del mod ord topLvl">
          <ac:chgData name="Paulo Eduardo Toscano Soares" userId="e475f443e47629d7" providerId="LiveId" clId="{6524F136-50C8-42E5-B116-EF45A5FE31FE}" dt="2021-05-05T21:58:51.291" v="90" actId="478"/>
          <ac:spMkLst>
            <pc:docMk/>
            <pc:sldMk cId="2767018269" sldId="256"/>
            <ac:spMk id="26" creationId="{0ED2F0DA-AF7E-4E1F-8D6F-4ABC8B6108C6}"/>
          </ac:spMkLst>
        </pc:spChg>
        <pc:spChg chg="add mod">
          <ac:chgData name="Paulo Eduardo Toscano Soares" userId="e475f443e47629d7" providerId="LiveId" clId="{6524F136-50C8-42E5-B116-EF45A5FE31FE}" dt="2021-05-05T22:15:04.700" v="249" actId="164"/>
          <ac:spMkLst>
            <pc:docMk/>
            <pc:sldMk cId="2767018269" sldId="256"/>
            <ac:spMk id="28" creationId="{DD539FC7-1D03-41B5-A5A8-03B6EF8BDAF4}"/>
          </ac:spMkLst>
        </pc:spChg>
        <pc:spChg chg="add del mod">
          <ac:chgData name="Paulo Eduardo Toscano Soares" userId="e475f443e47629d7" providerId="LiveId" clId="{6524F136-50C8-42E5-B116-EF45A5FE31FE}" dt="2021-05-05T21:57:06.470" v="48" actId="478"/>
          <ac:spMkLst>
            <pc:docMk/>
            <pc:sldMk cId="2767018269" sldId="256"/>
            <ac:spMk id="28" creationId="{F58463A0-B6AE-40EC-985B-4BBE49DAC9B7}"/>
          </ac:spMkLst>
        </pc:spChg>
        <pc:spChg chg="add del mod ord topLvl">
          <ac:chgData name="Paulo Eduardo Toscano Soares" userId="e475f443e47629d7" providerId="LiveId" clId="{6524F136-50C8-42E5-B116-EF45A5FE31FE}" dt="2021-05-05T23:11:47.042" v="262" actId="14100"/>
          <ac:spMkLst>
            <pc:docMk/>
            <pc:sldMk cId="2767018269" sldId="256"/>
            <ac:spMk id="31" creationId="{8B92A82F-9664-4449-A047-AEBACB44E10D}"/>
          </ac:spMkLst>
        </pc:spChg>
        <pc:spChg chg="del mod ord topLvl">
          <ac:chgData name="Paulo Eduardo Toscano Soares" userId="e475f443e47629d7" providerId="LiveId" clId="{6524F136-50C8-42E5-B116-EF45A5FE31FE}" dt="2021-05-05T23:10:45.155" v="256" actId="478"/>
          <ac:spMkLst>
            <pc:docMk/>
            <pc:sldMk cId="2767018269" sldId="256"/>
            <ac:spMk id="33" creationId="{0E0418D3-976B-404E-A8F2-73C3DDFD0246}"/>
          </ac:spMkLst>
        </pc:spChg>
        <pc:spChg chg="mod ord topLvl">
          <ac:chgData name="Paulo Eduardo Toscano Soares" userId="e475f443e47629d7" providerId="LiveId" clId="{6524F136-50C8-42E5-B116-EF45A5FE31FE}" dt="2021-05-05T22:15:04.700" v="249" actId="164"/>
          <ac:spMkLst>
            <pc:docMk/>
            <pc:sldMk cId="2767018269" sldId="256"/>
            <ac:spMk id="50" creationId="{4623E5C8-C96C-49D6-A3DA-65324B709C33}"/>
          </ac:spMkLst>
        </pc:spChg>
        <pc:grpChg chg="del mod">
          <ac:chgData name="Paulo Eduardo Toscano Soares" userId="e475f443e47629d7" providerId="LiveId" clId="{6524F136-50C8-42E5-B116-EF45A5FE31FE}" dt="2021-05-05T21:53:44.082" v="8" actId="165"/>
          <ac:grpSpMkLst>
            <pc:docMk/>
            <pc:sldMk cId="2767018269" sldId="256"/>
            <ac:grpSpMk id="2" creationId="{7A9A0338-241C-4FB1-884B-5EADD6352DC4}"/>
          </ac:grpSpMkLst>
        </pc:grpChg>
        <pc:grpChg chg="add del mod">
          <ac:chgData name="Paulo Eduardo Toscano Soares" userId="e475f443e47629d7" providerId="LiveId" clId="{6524F136-50C8-42E5-B116-EF45A5FE31FE}" dt="2021-05-05T22:09:38.394" v="186" actId="165"/>
          <ac:grpSpMkLst>
            <pc:docMk/>
            <pc:sldMk cId="2767018269" sldId="256"/>
            <ac:grpSpMk id="4" creationId="{231F5061-7B60-43D5-8EA6-E727F2EEEFA9}"/>
          </ac:grpSpMkLst>
        </pc:grpChg>
        <pc:grpChg chg="mod ord">
          <ac:chgData name="Paulo Eduardo Toscano Soares" userId="e475f443e47629d7" providerId="LiveId" clId="{6524F136-50C8-42E5-B116-EF45A5FE31FE}" dt="2021-05-05T22:15:08.922" v="250" actId="166"/>
          <ac:grpSpMkLst>
            <pc:docMk/>
            <pc:sldMk cId="2767018269" sldId="256"/>
            <ac:grpSpMk id="6" creationId="{F8FDC8E0-B18B-439A-820B-3E735891294A}"/>
          </ac:grpSpMkLst>
        </pc:grpChg>
        <pc:grpChg chg="add mod ord">
          <ac:chgData name="Paulo Eduardo Toscano Soares" userId="e475f443e47629d7" providerId="LiveId" clId="{6524F136-50C8-42E5-B116-EF45A5FE31FE}" dt="2021-05-05T22:15:31.211" v="253" actId="1076"/>
          <ac:grpSpMkLst>
            <pc:docMk/>
            <pc:sldMk cId="2767018269" sldId="256"/>
            <ac:grpSpMk id="10" creationId="{E35B5DFA-4C44-4CFC-8025-CB150F0797EC}"/>
          </ac:grpSpMkLst>
        </pc:grpChg>
        <pc:grpChg chg="add del mod topLvl">
          <ac:chgData name="Paulo Eduardo Toscano Soares" userId="e475f443e47629d7" providerId="LiveId" clId="{6524F136-50C8-42E5-B116-EF45A5FE31FE}" dt="2021-05-05T22:11:49.022" v="201" actId="478"/>
          <ac:grpSpMkLst>
            <pc:docMk/>
            <pc:sldMk cId="2767018269" sldId="256"/>
            <ac:grpSpMk id="12" creationId="{5AE41B3E-FC35-4B18-B3B0-8CB86E06DDE9}"/>
          </ac:grpSpMkLst>
        </pc:grpChg>
        <pc:grpChg chg="add del mod">
          <ac:chgData name="Paulo Eduardo Toscano Soares" userId="e475f443e47629d7" providerId="LiveId" clId="{6524F136-50C8-42E5-B116-EF45A5FE31FE}" dt="2021-05-05T22:11:46.855" v="200" actId="165"/>
          <ac:grpSpMkLst>
            <pc:docMk/>
            <pc:sldMk cId="2767018269" sldId="256"/>
            <ac:grpSpMk id="13" creationId="{13B9913B-5831-489B-9F09-5F7C47B3F20B}"/>
          </ac:grpSpMkLst>
        </pc:grpChg>
        <pc:grpChg chg="add mod">
          <ac:chgData name="Paulo Eduardo Toscano Soares" userId="e475f443e47629d7" providerId="LiveId" clId="{6524F136-50C8-42E5-B116-EF45A5FE31FE}" dt="2021-05-05T22:15:04.700" v="249" actId="164"/>
          <ac:grpSpMkLst>
            <pc:docMk/>
            <pc:sldMk cId="2767018269" sldId="256"/>
            <ac:grpSpMk id="19" creationId="{06605EFB-19FF-4B1D-9144-FC47BF74C57C}"/>
          </ac:grpSpMkLst>
        </pc:grpChg>
        <pc:picChg chg="add mod">
          <ac:chgData name="Paulo Eduardo Toscano Soares" userId="e475f443e47629d7" providerId="LiveId" clId="{6524F136-50C8-42E5-B116-EF45A5FE31FE}" dt="2021-05-05T22:10:37.692" v="199" actId="208"/>
          <ac:picMkLst>
            <pc:docMk/>
            <pc:sldMk cId="2767018269" sldId="256"/>
            <ac:picMk id="3" creationId="{45AB1EE4-C6BF-4FA8-873D-F12C20BCB740}"/>
          </ac:picMkLst>
        </pc:picChg>
        <pc:picChg chg="add mod ord">
          <ac:chgData name="Paulo Eduardo Toscano Soares" userId="e475f443e47629d7" providerId="LiveId" clId="{6524F136-50C8-42E5-B116-EF45A5FE31FE}" dt="2021-05-05T22:11:46.855" v="200" actId="165"/>
          <ac:picMkLst>
            <pc:docMk/>
            <pc:sldMk cId="2767018269" sldId="256"/>
            <ac:picMk id="11" creationId="{3BB8F293-2136-4D7F-96C0-DD217709EF26}"/>
          </ac:picMkLst>
        </pc:picChg>
        <pc:picChg chg="add mod ord">
          <ac:chgData name="Paulo Eduardo Toscano Soares" userId="e475f443e47629d7" providerId="LiveId" clId="{6524F136-50C8-42E5-B116-EF45A5FE31FE}" dt="2021-05-05T22:15:04.700" v="249" actId="164"/>
          <ac:picMkLst>
            <pc:docMk/>
            <pc:sldMk cId="2767018269" sldId="256"/>
            <ac:picMk id="15" creationId="{001BED07-C572-4323-BBD6-CC14A11613A5}"/>
          </ac:picMkLst>
        </pc:picChg>
        <pc:picChg chg="del mod topLvl">
          <ac:chgData name="Paulo Eduardo Toscano Soares" userId="e475f443e47629d7" providerId="LiveId" clId="{6524F136-50C8-42E5-B116-EF45A5FE31FE}" dt="2021-05-05T21:58:49.916" v="89" actId="478"/>
          <ac:picMkLst>
            <pc:docMk/>
            <pc:sldMk cId="2767018269" sldId="256"/>
            <ac:picMk id="36" creationId="{11A46ACB-2EDE-4875-A48D-5869348FE447}"/>
          </ac:picMkLst>
        </pc:picChg>
        <pc:picChg chg="del mod topLvl">
          <ac:chgData name="Paulo Eduardo Toscano Soares" userId="e475f443e47629d7" providerId="LiveId" clId="{6524F136-50C8-42E5-B116-EF45A5FE31FE}" dt="2021-05-05T22:09:41.139" v="187" actId="478"/>
          <ac:picMkLst>
            <pc:docMk/>
            <pc:sldMk cId="2767018269" sldId="256"/>
            <ac:picMk id="42" creationId="{969707C4-3EA8-447F-AF02-266AB803D588}"/>
          </ac:picMkLst>
        </pc:picChg>
        <pc:cxnChg chg="add del mod">
          <ac:chgData name="Paulo Eduardo Toscano Soares" userId="e475f443e47629d7" providerId="LiveId" clId="{6524F136-50C8-42E5-B116-EF45A5FE31FE}" dt="2021-05-05T22:13:49.006" v="235" actId="478"/>
          <ac:cxnSpMkLst>
            <pc:docMk/>
            <pc:sldMk cId="2767018269" sldId="256"/>
            <ac:cxnSpMk id="18" creationId="{D36BBBB0-8817-4719-880F-6425B6F238E3}"/>
          </ac:cxnSpMkLst>
        </pc:cxnChg>
      </pc:sldChg>
      <pc:sldChg chg="delSp add mod modShow">
        <pc:chgData name="Paulo Eduardo Toscano Soares" userId="e475f443e47629d7" providerId="LiveId" clId="{6524F136-50C8-42E5-B116-EF45A5FE31FE}" dt="2021-05-05T21:53:34.974" v="6" actId="478"/>
        <pc:sldMkLst>
          <pc:docMk/>
          <pc:sldMk cId="2373599612" sldId="257"/>
        </pc:sldMkLst>
        <pc:picChg chg="del">
          <ac:chgData name="Paulo Eduardo Toscano Soares" userId="e475f443e47629d7" providerId="LiveId" clId="{6524F136-50C8-42E5-B116-EF45A5FE31FE}" dt="2021-05-05T21:53:34.974" v="6" actId="478"/>
          <ac:picMkLst>
            <pc:docMk/>
            <pc:sldMk cId="2373599612" sldId="257"/>
            <ac:picMk id="11" creationId="{3BB8F293-2136-4D7F-96C0-DD217709EF2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00D8CA-47CA-4DCB-A039-E3E99DA781D5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F070A1-2191-4B0C-9729-F58F599C72D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74248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F070A1-2191-4B0C-9729-F58F599C72D7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253920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66" indent="0" algn="ctr">
              <a:buNone/>
              <a:defRPr sz="1500"/>
            </a:lvl2pPr>
            <a:lvl3pPr marL="685732" indent="0" algn="ctr">
              <a:buNone/>
              <a:defRPr sz="1350"/>
            </a:lvl3pPr>
            <a:lvl4pPr marL="1028599" indent="0" algn="ctr">
              <a:buNone/>
              <a:defRPr sz="1200"/>
            </a:lvl4pPr>
            <a:lvl5pPr marL="1371464" indent="0" algn="ctr">
              <a:buNone/>
              <a:defRPr sz="1200"/>
            </a:lvl5pPr>
            <a:lvl6pPr marL="1714331" indent="0" algn="ctr">
              <a:buNone/>
              <a:defRPr sz="1200"/>
            </a:lvl6pPr>
            <a:lvl7pPr marL="2057197" indent="0" algn="ctr">
              <a:buNone/>
              <a:defRPr sz="1200"/>
            </a:lvl7pPr>
            <a:lvl8pPr marL="2400063" indent="0" algn="ctr">
              <a:buNone/>
              <a:defRPr sz="1200"/>
            </a:lvl8pPr>
            <a:lvl9pPr marL="2742929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10365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86969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89857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58957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3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38702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53470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6" indent="0">
              <a:buNone/>
              <a:defRPr sz="1500" b="1"/>
            </a:lvl2pPr>
            <a:lvl3pPr marL="685732" indent="0">
              <a:buNone/>
              <a:defRPr sz="1350" b="1"/>
            </a:lvl3pPr>
            <a:lvl4pPr marL="1028599" indent="0">
              <a:buNone/>
              <a:defRPr sz="1200" b="1"/>
            </a:lvl4pPr>
            <a:lvl5pPr marL="1371464" indent="0">
              <a:buNone/>
              <a:defRPr sz="1200" b="1"/>
            </a:lvl5pPr>
            <a:lvl6pPr marL="1714331" indent="0">
              <a:buNone/>
              <a:defRPr sz="1200" b="1"/>
            </a:lvl6pPr>
            <a:lvl7pPr marL="2057197" indent="0">
              <a:buNone/>
              <a:defRPr sz="1200" b="1"/>
            </a:lvl7pPr>
            <a:lvl8pPr marL="2400063" indent="0">
              <a:buNone/>
              <a:defRPr sz="1200" b="1"/>
            </a:lvl8pPr>
            <a:lvl9pPr marL="2742929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7817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98069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0617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08626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66" indent="0">
              <a:buNone/>
              <a:defRPr sz="2100"/>
            </a:lvl2pPr>
            <a:lvl3pPr marL="685732" indent="0">
              <a:buNone/>
              <a:defRPr sz="1800"/>
            </a:lvl3pPr>
            <a:lvl4pPr marL="1028599" indent="0">
              <a:buNone/>
              <a:defRPr sz="1500"/>
            </a:lvl4pPr>
            <a:lvl5pPr marL="1371464" indent="0">
              <a:buNone/>
              <a:defRPr sz="1500"/>
            </a:lvl5pPr>
            <a:lvl6pPr marL="1714331" indent="0">
              <a:buNone/>
              <a:defRPr sz="1500"/>
            </a:lvl6pPr>
            <a:lvl7pPr marL="2057197" indent="0">
              <a:buNone/>
              <a:defRPr sz="1500"/>
            </a:lvl7pPr>
            <a:lvl8pPr marL="2400063" indent="0">
              <a:buNone/>
              <a:defRPr sz="1500"/>
            </a:lvl8pPr>
            <a:lvl9pPr marL="2742929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66" indent="0">
              <a:buNone/>
              <a:defRPr sz="1050"/>
            </a:lvl2pPr>
            <a:lvl3pPr marL="685732" indent="0">
              <a:buNone/>
              <a:defRPr sz="900"/>
            </a:lvl3pPr>
            <a:lvl4pPr marL="1028599" indent="0">
              <a:buNone/>
              <a:defRPr sz="750"/>
            </a:lvl4pPr>
            <a:lvl5pPr marL="1371464" indent="0">
              <a:buNone/>
              <a:defRPr sz="750"/>
            </a:lvl5pPr>
            <a:lvl6pPr marL="1714331" indent="0">
              <a:buNone/>
              <a:defRPr sz="750"/>
            </a:lvl6pPr>
            <a:lvl7pPr marL="2057197" indent="0">
              <a:buNone/>
              <a:defRPr sz="750"/>
            </a:lvl7pPr>
            <a:lvl8pPr marL="2400063" indent="0">
              <a:buNone/>
              <a:defRPr sz="750"/>
            </a:lvl8pPr>
            <a:lvl9pPr marL="2742929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9839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8FD78-D972-431E-81B3-F14313A59BB4}" type="datetimeFigureOut">
              <a:rPr lang="pt-BR" smtClean="0"/>
              <a:t>24/05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A49960-601F-4BB6-957A-DE3451E669E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74081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3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3" indent="-171433" algn="l" defTabSz="68573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99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6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3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98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64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30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496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362" indent="-171433" algn="l" defTabSz="6857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66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32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9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64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31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197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63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29" algn="l" defTabSz="6857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ixaDeTexto 6">
            <a:extLst>
              <a:ext uri="{FF2B5EF4-FFF2-40B4-BE49-F238E27FC236}">
                <a16:creationId xmlns:a16="http://schemas.microsoft.com/office/drawing/2014/main" id="{AB638C95-E367-44F2-A928-2BEBEC9AD8DE}"/>
              </a:ext>
            </a:extLst>
          </p:cNvPr>
          <p:cNvSpPr txBox="1"/>
          <p:nvPr/>
        </p:nvSpPr>
        <p:spPr>
          <a:xfrm>
            <a:off x="0" y="9389874"/>
            <a:ext cx="6817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/>
              <a:t>S1_File </a:t>
            </a:r>
            <a:endParaRPr lang="pt-BR" dirty="0"/>
          </a:p>
        </p:txBody>
      </p:sp>
      <p:pic>
        <p:nvPicPr>
          <p:cNvPr id="19" name="Imagem 18">
            <a:extLst>
              <a:ext uri="{FF2B5EF4-FFF2-40B4-BE49-F238E27FC236}">
                <a16:creationId xmlns:a16="http://schemas.microsoft.com/office/drawing/2014/main" id="{9FD6BB6F-A6D1-4152-95D7-AC30E4B86C93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23" y="513026"/>
            <a:ext cx="6740039" cy="553998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8" name="Tabela 7">
            <a:extLst>
              <a:ext uri="{FF2B5EF4-FFF2-40B4-BE49-F238E27FC236}">
                <a16:creationId xmlns:a16="http://schemas.microsoft.com/office/drawing/2014/main" id="{BF185CB9-0331-4C76-BE15-788343639F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7164864"/>
              </p:ext>
            </p:extLst>
          </p:nvPr>
        </p:nvGraphicFramePr>
        <p:xfrm>
          <a:off x="4843190" y="1550901"/>
          <a:ext cx="1844712" cy="876618"/>
        </p:xfrm>
        <a:graphic>
          <a:graphicData uri="http://schemas.openxmlformats.org/drawingml/2006/table">
            <a:tbl>
              <a:tblPr firstRow="1" firstCol="1" bandRow="1"/>
              <a:tblGrid>
                <a:gridCol w="315894">
                  <a:extLst>
                    <a:ext uri="{9D8B030D-6E8A-4147-A177-3AD203B41FA5}">
                      <a16:colId xmlns:a16="http://schemas.microsoft.com/office/drawing/2014/main" val="2241372503"/>
                    </a:ext>
                  </a:extLst>
                </a:gridCol>
                <a:gridCol w="615449">
                  <a:extLst>
                    <a:ext uri="{9D8B030D-6E8A-4147-A177-3AD203B41FA5}">
                      <a16:colId xmlns:a16="http://schemas.microsoft.com/office/drawing/2014/main" val="541993089"/>
                    </a:ext>
                  </a:extLst>
                </a:gridCol>
                <a:gridCol w="913369">
                  <a:extLst>
                    <a:ext uri="{9D8B030D-6E8A-4147-A177-3AD203B41FA5}">
                      <a16:colId xmlns:a16="http://schemas.microsoft.com/office/drawing/2014/main" val="3973370508"/>
                    </a:ext>
                  </a:extLst>
                </a:gridCol>
              </a:tblGrid>
              <a:tr h="12216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 dirty="0"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pt-BR" sz="8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 dirty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Freq.  </a:t>
                      </a:r>
                      <a:endParaRPr lang="pt-BR" sz="8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% of non-gaps 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1365256"/>
                  </a:ext>
                </a:extLst>
              </a:tr>
              <a:tr h="1187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674,229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 dirty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32.1%</a:t>
                      </a:r>
                      <a:endParaRPr lang="pt-BR" sz="8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7948645"/>
                  </a:ext>
                </a:extLst>
              </a:tr>
              <a:tr h="1187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C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419,299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20.0%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9019576"/>
                  </a:ext>
                </a:extLst>
              </a:tr>
              <a:tr h="1187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G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291,456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 dirty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13.9%</a:t>
                      </a:r>
                      <a:endParaRPr lang="pt-BR" sz="8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9547131"/>
                  </a:ext>
                </a:extLst>
              </a:tr>
              <a:tr h="1187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T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715,878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34.1%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555912"/>
                  </a:ext>
                </a:extLst>
              </a:tr>
              <a:tr h="1187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GC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710,755  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24.5%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2081781"/>
                  </a:ext>
                </a:extLst>
              </a:tr>
              <a:tr h="1187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-</a:t>
                      </a:r>
                      <a:endParaRPr lang="pt-BR" sz="8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 dirty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801,447  </a:t>
                      </a:r>
                      <a:endParaRPr lang="pt-BR" sz="8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pt-BR" sz="800" b="0" dirty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27.6% (</a:t>
                      </a:r>
                      <a:r>
                        <a:rPr lang="pt-BR" sz="800" b="0" dirty="0" err="1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of</a:t>
                      </a:r>
                      <a:r>
                        <a:rPr lang="pt-BR" sz="800" b="0" dirty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 </a:t>
                      </a:r>
                      <a:r>
                        <a:rPr lang="pt-BR" sz="800" b="0" dirty="0" err="1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ny</a:t>
                      </a:r>
                      <a:r>
                        <a:rPr lang="pt-BR" sz="800" b="0" dirty="0">
                          <a:effectLst/>
                          <a:latin typeface="monospaced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)</a:t>
                      </a:r>
                      <a:endParaRPr lang="pt-BR" sz="8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4811654"/>
                  </a:ext>
                </a:extLst>
              </a:tr>
            </a:tbl>
          </a:graphicData>
        </a:graphic>
      </p:graphicFrame>
      <p:sp>
        <p:nvSpPr>
          <p:cNvPr id="9" name="Rectangle 4">
            <a:extLst>
              <a:ext uri="{FF2B5EF4-FFF2-40B4-BE49-F238E27FC236}">
                <a16:creationId xmlns:a16="http://schemas.microsoft.com/office/drawing/2014/main" id="{6FF7609D-7599-485D-9748-FCCAC3DB6F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5914" y="1550901"/>
            <a:ext cx="1431802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pt-BR" altLang="pt-BR" sz="8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Length</a:t>
            </a:r>
            <a:r>
              <a:rPr kumimoji="0" lang="pt-BR" altLang="pt-B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: 22,131</a:t>
            </a:r>
            <a:endParaRPr kumimoji="0" lang="pt-BR" altLang="pt-B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pt-BR" altLang="pt-BR" sz="8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Sequences</a:t>
            </a:r>
            <a:r>
              <a:rPr kumimoji="0" lang="pt-BR" altLang="pt-B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: 8,489</a:t>
            </a:r>
            <a:endParaRPr kumimoji="0" lang="pt-BR" altLang="pt-B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pt-BR" altLang="pt-BR" sz="8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Identical</a:t>
            </a:r>
            <a:r>
              <a:rPr kumimoji="0" lang="pt-BR" altLang="pt-B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 Sites: 11,792 (54.2%)</a:t>
            </a:r>
            <a:endParaRPr kumimoji="0" lang="pt-BR" altLang="pt-BR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pt-BR" altLang="pt-BR" sz="8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Pairwise</a:t>
            </a:r>
            <a:r>
              <a:rPr kumimoji="0" lang="pt-BR" altLang="pt-B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 % </a:t>
            </a:r>
            <a:r>
              <a:rPr kumimoji="0" lang="pt-BR" altLang="pt-BR" sz="8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Identity</a:t>
            </a:r>
            <a:r>
              <a:rPr kumimoji="0" lang="pt-BR" altLang="pt-B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Times New Roman" panose="02020603050405020304" pitchFamily="18" charset="0"/>
                <a:cs typeface="Arial" panose="020B0604020202020204" pitchFamily="34" charset="0"/>
              </a:rPr>
              <a:t>: 98.4%</a:t>
            </a:r>
          </a:p>
        </p:txBody>
      </p:sp>
      <p:pic>
        <p:nvPicPr>
          <p:cNvPr id="24" name="Imagem 23">
            <a:extLst>
              <a:ext uri="{FF2B5EF4-FFF2-40B4-BE49-F238E27FC236}">
                <a16:creationId xmlns:a16="http://schemas.microsoft.com/office/drawing/2014/main" id="{A0467378-CB85-4137-A470-AFDE43C313DD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403305" y="2987960"/>
            <a:ext cx="6284597" cy="3110261"/>
          </a:xfrm>
          <a:prstGeom prst="rect">
            <a:avLst/>
          </a:prstGeom>
          <a:ln>
            <a:solidFill>
              <a:sysClr val="windowText" lastClr="000000"/>
            </a:solidFill>
          </a:ln>
        </p:spPr>
      </p:pic>
      <p:sp>
        <p:nvSpPr>
          <p:cNvPr id="28" name="CaixaDeTexto 27">
            <a:extLst>
              <a:ext uri="{FF2B5EF4-FFF2-40B4-BE49-F238E27FC236}">
                <a16:creationId xmlns:a16="http://schemas.microsoft.com/office/drawing/2014/main" id="{A20499B2-5BFD-4FA1-89CE-9CAEA077274A}"/>
              </a:ext>
            </a:extLst>
          </p:cNvPr>
          <p:cNvSpPr txBox="1"/>
          <p:nvPr/>
        </p:nvSpPr>
        <p:spPr>
          <a:xfrm>
            <a:off x="1583397" y="1550901"/>
            <a:ext cx="1718896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Coverage </a:t>
            </a: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21,769 bases:</a:t>
            </a:r>
            <a:endParaRPr kumimoji="0" lang="pt-BR" altLang="pt-B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Mean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131.2	</a:t>
            </a: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Std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Dev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50.3</a:t>
            </a:r>
            <a:endParaRPr kumimoji="0" lang="pt-BR" altLang="pt-B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Minimum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18	</a:t>
            </a: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Maximum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254</a:t>
            </a:r>
            <a:endParaRPr kumimoji="0" lang="pt-BR" altLang="pt-B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Forward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70.1	Reverse: 61.1</a:t>
            </a:r>
            <a:endParaRPr kumimoji="0" lang="pt-BR" altLang="pt-B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Ref-Seq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100% </a:t>
            </a: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pt-BR" altLang="pt-B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15,989 </a:t>
            </a:r>
            <a:r>
              <a:rPr kumimoji="0" lang="pt-BR" altLang="pt-BR" sz="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bp</a:t>
            </a:r>
            <a:endParaRPr kumimoji="0" lang="pt-BR" altLang="pt-BR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C773760D-F509-402B-B722-526235D51720}"/>
              </a:ext>
            </a:extLst>
          </p:cNvPr>
          <p:cNvSpPr txBox="1"/>
          <p:nvPr/>
        </p:nvSpPr>
        <p:spPr>
          <a:xfrm>
            <a:off x="2870880" y="1550901"/>
            <a:ext cx="1972310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Ungapped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lengths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8,488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reads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  <a:endParaRPr kumimoji="0" lang="pt-BR" altLang="pt-BR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Mean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245.6	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Std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Dev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84.7</a:t>
            </a:r>
            <a:endParaRPr kumimoji="0" lang="pt-BR" altLang="pt-BR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Minimum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30	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Maximum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411</a:t>
            </a:r>
            <a:endParaRPr kumimoji="0" lang="pt-BR" altLang="pt-BR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Confidence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Mean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27.1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(27.1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incl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trim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endParaRPr kumimoji="0" lang="pt-BR" altLang="pt-BR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Expected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Errors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: 23,837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(24,187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incl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trim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endParaRPr kumimoji="0" lang="pt-BR" altLang="pt-BR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At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least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Q20: 85.9%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(85.8%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incl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trim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srgbClr val="696969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endParaRPr kumimoji="0" lang="pt-BR" altLang="pt-BR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At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least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Q30: 40.8%</a:t>
            </a:r>
            <a:endParaRPr kumimoji="0" lang="pt-BR" altLang="pt-BR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/>
            </a:pP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At </a:t>
            </a:r>
            <a:r>
              <a:rPr kumimoji="0" lang="pt-BR" altLang="pt-BR" sz="8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least</a:t>
            </a:r>
            <a:r>
              <a:rPr kumimoji="0" lang="pt-BR" altLang="pt-BR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Times New Roman" panose="02020603050405020304" pitchFamily="18" charset="0"/>
                <a:cs typeface="Arial" panose="020B0604020202020204" pitchFamily="34" charset="0"/>
              </a:rPr>
              <a:t> Q40: 0.6%</a:t>
            </a:r>
            <a:endParaRPr lang="pt-BR" dirty="0"/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A026DACC-27C2-4470-9B6B-A94E379BE5ED}"/>
              </a:ext>
            </a:extLst>
          </p:cNvPr>
          <p:cNvSpPr txBox="1"/>
          <p:nvPr/>
        </p:nvSpPr>
        <p:spPr>
          <a:xfrm>
            <a:off x="39889" y="117623"/>
            <a:ext cx="363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/>
              <a:t>A</a:t>
            </a:r>
          </a:p>
        </p:txBody>
      </p:sp>
      <p:sp>
        <p:nvSpPr>
          <p:cNvPr id="33" name="CaixaDeTexto 32">
            <a:extLst>
              <a:ext uri="{FF2B5EF4-FFF2-40B4-BE49-F238E27FC236}">
                <a16:creationId xmlns:a16="http://schemas.microsoft.com/office/drawing/2014/main" id="{FA3FDC55-7873-4094-9A37-A42A9FD3D376}"/>
              </a:ext>
            </a:extLst>
          </p:cNvPr>
          <p:cNvSpPr txBox="1"/>
          <p:nvPr/>
        </p:nvSpPr>
        <p:spPr>
          <a:xfrm>
            <a:off x="44836" y="1350876"/>
            <a:ext cx="363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/>
              <a:t>B</a:t>
            </a:r>
          </a:p>
        </p:txBody>
      </p:sp>
      <p:sp>
        <p:nvSpPr>
          <p:cNvPr id="34" name="CaixaDeTexto 33">
            <a:extLst>
              <a:ext uri="{FF2B5EF4-FFF2-40B4-BE49-F238E27FC236}">
                <a16:creationId xmlns:a16="http://schemas.microsoft.com/office/drawing/2014/main" id="{5830BCF3-D1F4-440E-9F7D-BE0C1A3B8EFA}"/>
              </a:ext>
            </a:extLst>
          </p:cNvPr>
          <p:cNvSpPr txBox="1"/>
          <p:nvPr/>
        </p:nvSpPr>
        <p:spPr>
          <a:xfrm>
            <a:off x="62194" y="2659428"/>
            <a:ext cx="363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76701826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95</TotalTime>
  <Words>160</Words>
  <Application>Microsoft Office PowerPoint</Application>
  <PresentationFormat>Papel A4 (210 x 297 mm)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monospaced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Paulo Eduardo</dc:creator>
  <cp:lastModifiedBy>Daniel</cp:lastModifiedBy>
  <cp:revision>56</cp:revision>
  <dcterms:created xsi:type="dcterms:W3CDTF">2020-06-06T23:06:08Z</dcterms:created>
  <dcterms:modified xsi:type="dcterms:W3CDTF">2021-05-24T13:34:24Z</dcterms:modified>
</cp:coreProperties>
</file>